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9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8A4B88-A931-4F92-BA24-C77639965C5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A1260E-78B3-4E33-83F8-DAF82D09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231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4CB8B9-9E9F-25A6-FA16-3D7366C2D1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06533E1-E98A-093A-E798-2D391BBC88E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126226D-83CE-F164-80D1-E0C39B78E25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734F3D-D82F-9954-5F26-D3F3FC4F95C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1260E-78B3-4E33-83F8-DAF82D09712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7807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5CCE310-04C6-6E2B-59A7-878B357D39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7CBF9F3-5890-762D-DB54-D969C55F672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02EBD05-53F2-F56F-C903-4641F40F7D3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EE4687-1ADF-79DF-F796-8E0B8AA2D4E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1260E-78B3-4E33-83F8-DAF82D09712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22814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1C8B4F-02E5-42D5-83E2-2FF4C2EC88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32ABCC2-CF1C-AF34-C738-DE222EC174C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A43EAED-EB84-C27E-1BE7-8443CE7A56D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9B874A-3980-72B4-4989-97F9051D829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A1260E-78B3-4E33-83F8-DAF82D09712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25866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B1382-DF99-9C58-205B-58D803CFF2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3EBF7B-E474-9466-198C-1B8506D27F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ACB4D7-6A2F-3972-D3C0-2D4B139B6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C31783-0227-C376-3A46-DF64A1EC2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8C501E-57D4-4565-1998-FF67FE2F9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125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2D0ED-E473-5845-4615-A6A1D7E02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5BD20F-7125-E58F-6A6F-01BEA699B5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FDAA9-01F3-9C4B-6D0D-5F642CF7D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C7D5E-9FC1-7EA7-F85B-955C82B59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0CEA01-D4FE-FE8A-4A61-21B7BDD09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806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176894-3D08-B6D9-6B59-E35D43367F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74B6F6-05B1-04A0-4984-69B8CDC964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3B8EF6-6232-1693-A167-86A3585C7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8E243-7DF4-15BC-2756-4C39AD832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789FC1-692D-B559-ADDE-6DE2E05EF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34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1F996-DADD-A6DD-E61A-D75AB1CFF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BAA50E-253E-B68A-77F2-4C491882EC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4A529E-949C-2A02-5615-D2B1163AA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E3B48-ADA8-6541-C42A-9F82CE29A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F5006-E9E7-FF50-A45A-272E93426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828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A39DDC-B270-127C-C31F-FB742DA46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82CCF0-478C-174E-6F7D-8588648AFB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636A68-BFBA-718C-B44F-04BCA3114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2319C5-230A-1E59-CBB4-38315BDCA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FEBB8-1D43-3DFF-60E5-651360449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7893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29E973-C4F0-6BEA-D327-BF0AFF3BE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E3B706-0DCB-3B99-52E4-59A7BF4FC8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2B24EF-142D-6A2B-2B54-4F0BE90E5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614C7B-75E5-1DE1-389E-CBFD51B48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95E10-20C1-9428-C426-164663D26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94EB5-4A09-25FB-B372-A07AAD121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98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565D1-A226-300A-86E2-3EF8B5AFA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B76208-4DE0-7A2D-44AE-ABD2427550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67AD5B-1391-BDFD-D19B-7B8469FE7B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F36574-5B94-C93C-1B4C-61D4EB2703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3CB5718-4DD4-EF9C-24E9-3354A12A53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3B9661-C400-C1FB-BB07-3C1F0B133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3620FE-4089-7127-0E32-3C8E66315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337069-7114-523D-2331-63102328E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053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A3398-0C2D-B63E-C23B-412F645653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9944E2-9CE6-E048-B1E1-3A8B33129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EBCCDD-EDF2-763F-E864-94A829FF6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2C502D-B44C-B17F-933F-49552F5CB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25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0A205D-1200-C3B3-6538-0AC0820E8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9489F1-D648-3F23-C0B2-A69854302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8144C0-6018-40AE-F6A1-91B2494EA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7098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9519E-487B-C3EE-892F-F33566EB4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2B8EF0-3AD9-7F08-3B6A-BF59D7EB4B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F1013D-7A0D-C527-B09E-E5EA9A5383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95EDF6-1D27-4C9D-76DA-628C750E9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7E0E8B-26D1-4B14-624D-F965C5A4E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81E489-D5E4-600E-F523-6937B212E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167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B8D46-9B05-2040-4336-FA8143D0B4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D11AF4-6EB1-FB79-0060-F618B09944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30CFB8-325A-0D50-AA1E-A3939D4A02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BDB384-BF31-B15D-B56A-57DB9A6C0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702B9-6256-417D-78B6-A86992DEE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79160-4545-E9CA-5B82-53DFBCD01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406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3632DE-494D-A2AA-099F-4F2F344B6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5A5BC5-9235-29C3-48E8-7C9B27AC4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6CB0AE-AE5A-43FB-94EA-FD9FDF5B2C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16AAE7-72B6-4B86-B4D0-6A72D5B43481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A0A04B-D9A7-EFF6-D0E0-1B44F9E79A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E15D6-D2FA-EEDF-1608-8175A2B2F0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EF6D4E-2E9A-43B7-BAD6-7A9410ABBB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749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82E7E0-1AFB-D10D-1A66-C497A33C0A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4C32817-C45F-A1DA-291E-1866A1C2DA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25009" t="15009" r="35464" b="28129"/>
          <a:stretch>
            <a:fillRect/>
          </a:stretch>
        </p:blipFill>
        <p:spPr>
          <a:xfrm>
            <a:off x="3685591" y="2090056"/>
            <a:ext cx="2547257" cy="29298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09AD03B-9C98-217E-8327-4BA5C214A1EB}"/>
              </a:ext>
            </a:extLst>
          </p:cNvPr>
          <p:cNvSpPr/>
          <p:nvPr/>
        </p:nvSpPr>
        <p:spPr>
          <a:xfrm>
            <a:off x="5021095" y="3157009"/>
            <a:ext cx="992221" cy="53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0F31D14-906D-E291-CE20-98C51F58EB47}"/>
              </a:ext>
            </a:extLst>
          </p:cNvPr>
          <p:cNvSpPr txBox="1"/>
          <p:nvPr/>
        </p:nvSpPr>
        <p:spPr>
          <a:xfrm>
            <a:off x="6232848" y="3291242"/>
            <a:ext cx="1166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WASP 60 </a:t>
            </a:r>
            <a:r>
              <a:rPr lang="en-GB" sz="1200" dirty="0" err="1"/>
              <a:t>kD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03B374-4619-C482-2C3D-C9BD6E8723BD}"/>
              </a:ext>
            </a:extLst>
          </p:cNvPr>
          <p:cNvSpPr txBox="1"/>
          <p:nvPr/>
        </p:nvSpPr>
        <p:spPr>
          <a:xfrm>
            <a:off x="405570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DF96B3-FD6B-EEE3-A817-04A0ED901674}"/>
              </a:ext>
            </a:extLst>
          </p:cNvPr>
          <p:cNvSpPr txBox="1"/>
          <p:nvPr/>
        </p:nvSpPr>
        <p:spPr>
          <a:xfrm>
            <a:off x="4334479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5ECC93-EF92-6359-9847-BD213E170C4C}"/>
              </a:ext>
            </a:extLst>
          </p:cNvPr>
          <p:cNvSpPr txBox="1"/>
          <p:nvPr/>
        </p:nvSpPr>
        <p:spPr>
          <a:xfrm>
            <a:off x="4613251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8A4781-AC93-4F16-7224-904D08073AD1}"/>
              </a:ext>
            </a:extLst>
          </p:cNvPr>
          <p:cNvSpPr txBox="1"/>
          <p:nvPr/>
        </p:nvSpPr>
        <p:spPr>
          <a:xfrm>
            <a:off x="4892023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D6FCCFC-72CF-5E59-C3E2-B14863931E40}"/>
              </a:ext>
            </a:extLst>
          </p:cNvPr>
          <p:cNvSpPr txBox="1"/>
          <p:nvPr/>
        </p:nvSpPr>
        <p:spPr>
          <a:xfrm>
            <a:off x="5170795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539A05-E482-8541-2C00-03618D6C4B4A}"/>
              </a:ext>
            </a:extLst>
          </p:cNvPr>
          <p:cNvSpPr txBox="1"/>
          <p:nvPr/>
        </p:nvSpPr>
        <p:spPr>
          <a:xfrm>
            <a:off x="7193902" y="1671753"/>
            <a:ext cx="258731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dirty="0"/>
              <a:t>Wild-type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</a:t>
            </a:r>
          </a:p>
          <a:p>
            <a:pPr marL="342900" indent="-342900">
              <a:buAutoNum type="arabicPeriod"/>
            </a:pPr>
            <a:r>
              <a:rPr lang="en-GB" sz="1200" dirty="0"/>
              <a:t>WASP KO 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 + Empty vector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WASP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HA-WASP</a:t>
            </a:r>
          </a:p>
          <a:p>
            <a:pPr marL="342900" indent="-342900">
              <a:buFontTx/>
              <a:buAutoNum type="arabicPeriod"/>
            </a:pPr>
            <a:endParaRPr lang="en-GB" sz="1200" dirty="0"/>
          </a:p>
          <a:p>
            <a:pPr marL="342900" indent="-342900">
              <a:buAutoNum type="arabicPeriod"/>
            </a:pP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8A5B1CC-6F38-976C-385F-6ABF8E729020}"/>
              </a:ext>
            </a:extLst>
          </p:cNvPr>
          <p:cNvSpPr txBox="1"/>
          <p:nvPr/>
        </p:nvSpPr>
        <p:spPr>
          <a:xfrm>
            <a:off x="3282822" y="3156724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99BDF2-3E0F-AFF9-740B-E892158914B5}"/>
              </a:ext>
            </a:extLst>
          </p:cNvPr>
          <p:cNvSpPr txBox="1"/>
          <p:nvPr/>
        </p:nvSpPr>
        <p:spPr>
          <a:xfrm>
            <a:off x="3282822" y="3457737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945A4B-C214-641B-E072-9BBFB395252E}"/>
              </a:ext>
            </a:extLst>
          </p:cNvPr>
          <p:cNvSpPr txBox="1"/>
          <p:nvPr/>
        </p:nvSpPr>
        <p:spPr>
          <a:xfrm>
            <a:off x="572833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2271A5F-6241-4233-5683-727941B72616}"/>
              </a:ext>
            </a:extLst>
          </p:cNvPr>
          <p:cNvSpPr txBox="1"/>
          <p:nvPr/>
        </p:nvSpPr>
        <p:spPr>
          <a:xfrm>
            <a:off x="544956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7817091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666622-AAF7-7C50-62C9-BC81C28A2B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51D4B7F-1EB2-E387-5AA2-C24980259B3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8032" t="34302" r="42194" b="27551"/>
          <a:stretch>
            <a:fillRect/>
          </a:stretch>
        </p:blipFill>
        <p:spPr>
          <a:xfrm>
            <a:off x="3691150" y="2219325"/>
            <a:ext cx="2541698" cy="26090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6ED37E2-71D4-280A-5B15-40B5410A8277}"/>
              </a:ext>
            </a:extLst>
          </p:cNvPr>
          <p:cNvSpPr/>
          <p:nvPr/>
        </p:nvSpPr>
        <p:spPr>
          <a:xfrm>
            <a:off x="5021095" y="3157009"/>
            <a:ext cx="992221" cy="53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78AFA60-88B5-DB70-57A2-370C1131EC7D}"/>
              </a:ext>
            </a:extLst>
          </p:cNvPr>
          <p:cNvSpPr txBox="1"/>
          <p:nvPr/>
        </p:nvSpPr>
        <p:spPr>
          <a:xfrm>
            <a:off x="6232847" y="3291242"/>
            <a:ext cx="1510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A-WASP 60 </a:t>
            </a:r>
            <a:r>
              <a:rPr lang="en-GB" sz="1200" dirty="0" err="1"/>
              <a:t>kD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E01996-E4FD-2526-0D2B-4C4E62D55458}"/>
              </a:ext>
            </a:extLst>
          </p:cNvPr>
          <p:cNvSpPr txBox="1"/>
          <p:nvPr/>
        </p:nvSpPr>
        <p:spPr>
          <a:xfrm>
            <a:off x="403665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3FD5A5-F708-A3C3-5064-F766296F2DF5}"/>
              </a:ext>
            </a:extLst>
          </p:cNvPr>
          <p:cNvSpPr txBox="1"/>
          <p:nvPr/>
        </p:nvSpPr>
        <p:spPr>
          <a:xfrm>
            <a:off x="4315429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E4ADD4-047D-2337-F1EE-50D38DD236D1}"/>
              </a:ext>
            </a:extLst>
          </p:cNvPr>
          <p:cNvSpPr txBox="1"/>
          <p:nvPr/>
        </p:nvSpPr>
        <p:spPr>
          <a:xfrm>
            <a:off x="4594201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CC0EB0-520F-7881-00F7-0DA253F1424C}"/>
              </a:ext>
            </a:extLst>
          </p:cNvPr>
          <p:cNvSpPr txBox="1"/>
          <p:nvPr/>
        </p:nvSpPr>
        <p:spPr>
          <a:xfrm>
            <a:off x="4872973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C88EAA-41D2-F4CE-B588-F9882398F36B}"/>
              </a:ext>
            </a:extLst>
          </p:cNvPr>
          <p:cNvSpPr txBox="1"/>
          <p:nvPr/>
        </p:nvSpPr>
        <p:spPr>
          <a:xfrm>
            <a:off x="5151745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9EA7EB4-1924-CDBE-C933-1700C4CBED97}"/>
              </a:ext>
            </a:extLst>
          </p:cNvPr>
          <p:cNvSpPr txBox="1"/>
          <p:nvPr/>
        </p:nvSpPr>
        <p:spPr>
          <a:xfrm>
            <a:off x="7193902" y="1671753"/>
            <a:ext cx="258731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dirty="0"/>
              <a:t>Wild-type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</a:t>
            </a:r>
          </a:p>
          <a:p>
            <a:pPr marL="342900" indent="-342900">
              <a:buAutoNum type="arabicPeriod"/>
            </a:pPr>
            <a:r>
              <a:rPr lang="en-GB" sz="1200" dirty="0"/>
              <a:t>WASP KO 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 + Empty vector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WASP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HA-WASP</a:t>
            </a:r>
          </a:p>
          <a:p>
            <a:pPr marL="342900" indent="-342900">
              <a:buFontTx/>
              <a:buAutoNum type="arabicPeriod"/>
            </a:pPr>
            <a:endParaRPr lang="en-GB" sz="1200" dirty="0"/>
          </a:p>
          <a:p>
            <a:pPr marL="342900" indent="-342900">
              <a:buAutoNum type="arabicPeriod"/>
            </a:pP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B29526D-0834-04B2-33F6-61EB0C77DB91}"/>
              </a:ext>
            </a:extLst>
          </p:cNvPr>
          <p:cNvSpPr txBox="1"/>
          <p:nvPr/>
        </p:nvSpPr>
        <p:spPr>
          <a:xfrm>
            <a:off x="3282822" y="3156724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FF657F-476D-3108-71B3-090FAD6A0087}"/>
              </a:ext>
            </a:extLst>
          </p:cNvPr>
          <p:cNvSpPr txBox="1"/>
          <p:nvPr/>
        </p:nvSpPr>
        <p:spPr>
          <a:xfrm>
            <a:off x="3282822" y="3457737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9058EB-5D89-35BE-5EB0-B1B0DBCDB6F7}"/>
              </a:ext>
            </a:extLst>
          </p:cNvPr>
          <p:cNvSpPr txBox="1"/>
          <p:nvPr/>
        </p:nvSpPr>
        <p:spPr>
          <a:xfrm>
            <a:off x="570928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EF238B-795D-EBD6-5A18-AC1C6C921D6B}"/>
              </a:ext>
            </a:extLst>
          </p:cNvPr>
          <p:cNvSpPr txBox="1"/>
          <p:nvPr/>
        </p:nvSpPr>
        <p:spPr>
          <a:xfrm>
            <a:off x="543051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2158582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00DC35-4687-2B1E-63C9-1A7AC70860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2704A4D-6305-A77C-4D8B-4DF7BFBE6C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25624" t="36507" r="29579" b="13436"/>
          <a:stretch>
            <a:fillRect/>
          </a:stretch>
        </p:blipFill>
        <p:spPr>
          <a:xfrm>
            <a:off x="3658247" y="2382378"/>
            <a:ext cx="2630717" cy="23526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86B3FB7D-1737-5E92-F269-2C1BBADD196C}"/>
              </a:ext>
            </a:extLst>
          </p:cNvPr>
          <p:cNvSpPr/>
          <p:nvPr/>
        </p:nvSpPr>
        <p:spPr>
          <a:xfrm>
            <a:off x="5021095" y="3157009"/>
            <a:ext cx="992221" cy="532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111649-98C5-197D-8EE0-AC0B9807C3D7}"/>
              </a:ext>
            </a:extLst>
          </p:cNvPr>
          <p:cNvSpPr txBox="1"/>
          <p:nvPr/>
        </p:nvSpPr>
        <p:spPr>
          <a:xfrm>
            <a:off x="6232847" y="3291242"/>
            <a:ext cx="1510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GAPDH 37 </a:t>
            </a:r>
            <a:r>
              <a:rPr lang="en-GB" sz="1200" dirty="0" err="1"/>
              <a:t>kD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00BE45-2C80-39E3-253C-6DEAAD8FCCA6}"/>
              </a:ext>
            </a:extLst>
          </p:cNvPr>
          <p:cNvSpPr txBox="1"/>
          <p:nvPr/>
        </p:nvSpPr>
        <p:spPr>
          <a:xfrm>
            <a:off x="397950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8C1B37-D6D1-77F9-CADD-0BE1A60B5B1B}"/>
              </a:ext>
            </a:extLst>
          </p:cNvPr>
          <p:cNvSpPr txBox="1"/>
          <p:nvPr/>
        </p:nvSpPr>
        <p:spPr>
          <a:xfrm>
            <a:off x="4258279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25AD41-97FE-2035-F01E-FBBB1A48109E}"/>
              </a:ext>
            </a:extLst>
          </p:cNvPr>
          <p:cNvSpPr txBox="1"/>
          <p:nvPr/>
        </p:nvSpPr>
        <p:spPr>
          <a:xfrm>
            <a:off x="4537051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8C6C8F-454B-1D8C-470C-1A361D2C313D}"/>
              </a:ext>
            </a:extLst>
          </p:cNvPr>
          <p:cNvSpPr txBox="1"/>
          <p:nvPr/>
        </p:nvSpPr>
        <p:spPr>
          <a:xfrm>
            <a:off x="4815823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B8E1BA-517C-3B0D-CBBF-9D5ABC22C8C0}"/>
              </a:ext>
            </a:extLst>
          </p:cNvPr>
          <p:cNvSpPr txBox="1"/>
          <p:nvPr/>
        </p:nvSpPr>
        <p:spPr>
          <a:xfrm>
            <a:off x="5094595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666153B-40A7-F182-B1E2-0C5495A6F767}"/>
              </a:ext>
            </a:extLst>
          </p:cNvPr>
          <p:cNvSpPr txBox="1"/>
          <p:nvPr/>
        </p:nvSpPr>
        <p:spPr>
          <a:xfrm>
            <a:off x="7193902" y="1671753"/>
            <a:ext cx="258731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dirty="0"/>
              <a:t>Wild-type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</a:t>
            </a:r>
          </a:p>
          <a:p>
            <a:pPr marL="342900" indent="-342900">
              <a:buAutoNum type="arabicPeriod"/>
            </a:pPr>
            <a:r>
              <a:rPr lang="en-GB" sz="1200" dirty="0"/>
              <a:t>N-WASP KO</a:t>
            </a:r>
          </a:p>
          <a:p>
            <a:pPr marL="342900" indent="-342900">
              <a:buAutoNum type="arabicPeriod"/>
            </a:pPr>
            <a:r>
              <a:rPr lang="en-GB" sz="1200" dirty="0"/>
              <a:t>WASP KO </a:t>
            </a:r>
          </a:p>
          <a:p>
            <a:pPr marL="342900" indent="-342900">
              <a:buAutoNum type="arabicPeriod"/>
            </a:pPr>
            <a:r>
              <a:rPr lang="en-GB" sz="1200" dirty="0"/>
              <a:t>Non-target RNA + Empty vector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WASP</a:t>
            </a:r>
          </a:p>
          <a:p>
            <a:pPr marL="342900" indent="-342900">
              <a:buFontTx/>
              <a:buAutoNum type="arabicPeriod"/>
            </a:pPr>
            <a:r>
              <a:rPr lang="en-GB" sz="1200" dirty="0"/>
              <a:t>Non-target RNA + HA-WASP</a:t>
            </a:r>
          </a:p>
          <a:p>
            <a:pPr marL="342900" indent="-342900">
              <a:buFontTx/>
              <a:buAutoNum type="arabicPeriod"/>
            </a:pPr>
            <a:endParaRPr lang="en-GB" sz="1200" dirty="0"/>
          </a:p>
          <a:p>
            <a:pPr marL="342900" indent="-342900">
              <a:buAutoNum type="arabicPeriod"/>
            </a:pPr>
            <a:endParaRPr lang="en-GB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B98C92-5B5E-5FFE-A6CB-4A610DE4FD43}"/>
              </a:ext>
            </a:extLst>
          </p:cNvPr>
          <p:cNvSpPr txBox="1"/>
          <p:nvPr/>
        </p:nvSpPr>
        <p:spPr>
          <a:xfrm>
            <a:off x="3282822" y="3156724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F4EE92A-47DB-AA20-8B77-BEEBA51F2744}"/>
              </a:ext>
            </a:extLst>
          </p:cNvPr>
          <p:cNvSpPr txBox="1"/>
          <p:nvPr/>
        </p:nvSpPr>
        <p:spPr>
          <a:xfrm>
            <a:off x="3282822" y="3457737"/>
            <a:ext cx="408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4F40CB-E12C-8D5C-2EE7-364DFEF44D51}"/>
              </a:ext>
            </a:extLst>
          </p:cNvPr>
          <p:cNvSpPr txBox="1"/>
          <p:nvPr/>
        </p:nvSpPr>
        <p:spPr>
          <a:xfrm>
            <a:off x="565213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C5A802D-61CD-3595-B0DD-2CE1E38C976E}"/>
              </a:ext>
            </a:extLst>
          </p:cNvPr>
          <p:cNvSpPr txBox="1"/>
          <p:nvPr/>
        </p:nvSpPr>
        <p:spPr>
          <a:xfrm>
            <a:off x="5373367" y="2762512"/>
            <a:ext cx="2513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527409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99</Words>
  <Application>Microsoft Office PowerPoint</Application>
  <PresentationFormat>Widescreen</PresentationFormat>
  <Paragraphs>5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>SUND - 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han Thu Han Le</dc:creator>
  <cp:lastModifiedBy>Phan Thu Han Le</cp:lastModifiedBy>
  <cp:revision>4</cp:revision>
  <dcterms:created xsi:type="dcterms:W3CDTF">2025-12-11T11:13:17Z</dcterms:created>
  <dcterms:modified xsi:type="dcterms:W3CDTF">2025-12-11T11:48:08Z</dcterms:modified>
</cp:coreProperties>
</file>